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4" autoAdjust="0"/>
    <p:restoredTop sz="94658"/>
  </p:normalViewPr>
  <p:slideViewPr>
    <p:cSldViewPr snapToGrid="0">
      <p:cViewPr varScale="1">
        <p:scale>
          <a:sx n="120" d="100"/>
          <a:sy n="120" d="100"/>
        </p:scale>
        <p:origin x="8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083A47-01D1-F6BC-5296-3755C5FD6A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14C118-4C14-99EF-F390-B559DF9851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284674-E432-7B29-0F0B-0169BC8E2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69F80D-257C-0BA8-C845-FFC37E03D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F853CD-E522-AB0C-E22D-A41F3D3BD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375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6DE1F4-A640-899F-16C5-451567AD0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E9F016-A352-1AC9-B4F2-E9E0E765D1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06D35-27DB-1E06-AE68-D2C3A5C76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45280-3D20-3676-A377-B998C7E29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47C7AE-0FEA-9200-E9F2-C85DBE58A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430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F73D9A-7C20-7B7F-B379-1EACCD19E9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76744C-52F8-1C24-0AAF-BC51F39F0A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19BC04-D445-A47E-12CF-DE981DEC4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F8AD27-FB3D-9A30-ACCD-BC185A27A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06C548-91A8-2E92-2C8B-85C9A3689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020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1912F3-AA5D-B1B8-DECB-3F5806B28B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040AFB-4BB3-72E1-6A16-A4E5FCF7AF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631F3B-9530-931D-BE0C-459B3F703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6960F0-B628-CCE6-ED8F-364C6B3B5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1E5E0A-D96E-21B1-9139-CBE137E9D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270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21194-EFDE-8092-063E-FD9BEE9610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A6C96B-36F2-2D8E-152E-F33BFE27AC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17E92A-8C14-9F89-5A64-C0FD6AF44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3A6209-A668-4AC5-7ED8-956F1CDFB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8BDDBB-223F-C261-8271-40345086F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1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8D6C71-19CE-2811-CC85-3FB2F3B52E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38B542-C75C-D24A-C07C-1419F901E5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F4C995-F6ED-E59C-71CD-A7BCE71404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66E8DA-DD02-A561-871D-EC0766079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3E036D-A4A8-E09F-DE4E-E460E78C9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0E294E-9B01-7A7A-ED17-CBE31B2B3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4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11210-B890-C82A-EB5D-030865B72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6B42F-C087-3B59-DA5F-F579AC170A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350FBF-39D8-0F3C-EF2E-80299A6AAE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A266D4A-85A1-A25F-CE19-3ACFD47CCE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AC45D9-71E0-8193-5A9F-B0B2C5B929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558405D-BC1F-AAA1-A009-ECD3EB41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B0FB94-24CA-031F-0F0D-C0C258FC9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03086D-F6E8-6231-7B09-4D5C085D9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099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9F8051-A2A4-8647-E622-14FB09C283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47FFAB-B1E5-4C6C-57B6-A3ADD0E9BA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7904F7C-0AFB-BFA9-13F3-FC9A77D35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0A25F1-C972-6587-CBF7-CD566F160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538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D9232F-2FAA-2990-1565-39D0F1EE8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45AE0E-C562-13F4-1898-C3313427C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9F953E-D6D6-22D5-61B3-B45218E16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48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6643B-36DF-E1A7-A488-BF5A85D311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C8B678-74F4-FC20-7412-E97C991FF6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C7BE14-32CA-82FB-418F-874504BF50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53C3E8-5C89-EE25-56A0-2CD85A3F92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7E2117-AD0D-6396-72B2-FD265A679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98AEC6-A950-27B7-BE7E-A251411F6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036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E91523-75C9-B2C2-4976-ED80876E6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C19F29-21EB-10A7-F186-8D8BB01969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C77183-BF61-750B-2D59-50C79CB0D5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4FD12F-D64E-C207-48AC-38CAAB043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81B167-A05A-CCC0-4704-6C155660F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42C3B-0D31-8001-24CD-EC66D7B01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9656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7E226B-47E7-8787-87E8-D446103FC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77CAD6-A4BF-CDE0-9FF9-E7C9358EC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5B4729-3A74-F828-6C77-13F3AADB1C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D00032-4DB2-4B94-88DF-5ECA8A72A133}" type="datetimeFigureOut">
              <a:rPr lang="en-US" smtClean="0"/>
              <a:t>5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4517B-FB7C-20A5-49A3-E4BB43AED5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4D9D6C-7FCA-9AEA-106C-48E8B1A60E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4BDE1F-AB43-4C00-A677-8F29552E5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843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64CC91F-4DD9-0A8E-2EB9-8AC521A7418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826" t="7191" r="-240" b="9686"/>
          <a:stretch>
            <a:fillRect/>
          </a:stretch>
        </p:blipFill>
        <p:spPr>
          <a:xfrm>
            <a:off x="3467053" y="351577"/>
            <a:ext cx="6305596" cy="257888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9F89C48-89DD-2643-FDB6-D74B5B41917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755" b="18184"/>
          <a:stretch>
            <a:fillRect/>
          </a:stretch>
        </p:blipFill>
        <p:spPr>
          <a:xfrm>
            <a:off x="3467053" y="3620342"/>
            <a:ext cx="6266074" cy="261196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6887F07-26FB-12E9-E139-1C673FBF11BE}"/>
              </a:ext>
            </a:extLst>
          </p:cNvPr>
          <p:cNvSpPr txBox="1"/>
          <p:nvPr/>
        </p:nvSpPr>
        <p:spPr>
          <a:xfrm>
            <a:off x="4193065" y="2798259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DA8E6D-7960-4930-6328-50226E8C75AB}"/>
              </a:ext>
            </a:extLst>
          </p:cNvPr>
          <p:cNvSpPr txBox="1"/>
          <p:nvPr/>
        </p:nvSpPr>
        <p:spPr>
          <a:xfrm>
            <a:off x="5132835" y="2791207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245D94-4FF4-5608-D063-B08F51385E85}"/>
              </a:ext>
            </a:extLst>
          </p:cNvPr>
          <p:cNvSpPr txBox="1"/>
          <p:nvPr/>
        </p:nvSpPr>
        <p:spPr>
          <a:xfrm>
            <a:off x="6022802" y="279825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C409BB2-4291-DC3A-D0DF-49E98663F1F4}"/>
              </a:ext>
            </a:extLst>
          </p:cNvPr>
          <p:cNvSpPr txBox="1"/>
          <p:nvPr/>
        </p:nvSpPr>
        <p:spPr>
          <a:xfrm>
            <a:off x="7013402" y="279825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54C3C6-F9F3-CB53-A62E-367128B11E46}"/>
              </a:ext>
            </a:extLst>
          </p:cNvPr>
          <p:cNvSpPr txBox="1"/>
          <p:nvPr/>
        </p:nvSpPr>
        <p:spPr>
          <a:xfrm>
            <a:off x="8023052" y="279825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50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7303A5-07A3-125C-290E-0F0ADA15C9C6}"/>
              </a:ext>
            </a:extLst>
          </p:cNvPr>
          <p:cNvSpPr txBox="1"/>
          <p:nvPr/>
        </p:nvSpPr>
        <p:spPr>
          <a:xfrm>
            <a:off x="9032702" y="2798259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9655440-031C-ADAB-95E9-1C071FFB6B07}"/>
              </a:ext>
            </a:extLst>
          </p:cNvPr>
          <p:cNvSpPr txBox="1"/>
          <p:nvPr/>
        </p:nvSpPr>
        <p:spPr>
          <a:xfrm>
            <a:off x="4202244" y="6138506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0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2D6688-60A6-5726-8372-0CCF056FBA16}"/>
              </a:ext>
            </a:extLst>
          </p:cNvPr>
          <p:cNvSpPr txBox="1"/>
          <p:nvPr/>
        </p:nvSpPr>
        <p:spPr>
          <a:xfrm>
            <a:off x="5142014" y="613850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0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2655FBF-AFBF-A692-2D3D-8D95DFBD7434}"/>
              </a:ext>
            </a:extLst>
          </p:cNvPr>
          <p:cNvSpPr txBox="1"/>
          <p:nvPr/>
        </p:nvSpPr>
        <p:spPr>
          <a:xfrm>
            <a:off x="6031981" y="613850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0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D857C6-933C-7977-F912-73DACE758890}"/>
              </a:ext>
            </a:extLst>
          </p:cNvPr>
          <p:cNvSpPr txBox="1"/>
          <p:nvPr/>
        </p:nvSpPr>
        <p:spPr>
          <a:xfrm>
            <a:off x="7022581" y="613850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0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EFB9997-3B41-64B8-12E2-554A98325334}"/>
              </a:ext>
            </a:extLst>
          </p:cNvPr>
          <p:cNvSpPr txBox="1"/>
          <p:nvPr/>
        </p:nvSpPr>
        <p:spPr>
          <a:xfrm>
            <a:off x="8032231" y="613850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50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E4C1063-8B1C-450C-0813-7390814BE18A}"/>
              </a:ext>
            </a:extLst>
          </p:cNvPr>
          <p:cNvSpPr txBox="1"/>
          <p:nvPr/>
        </p:nvSpPr>
        <p:spPr>
          <a:xfrm>
            <a:off x="9041881" y="6138506"/>
            <a:ext cx="678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0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0C9E225-6678-179F-5C40-F01DC11D9544}"/>
              </a:ext>
            </a:extLst>
          </p:cNvPr>
          <p:cNvSpPr txBox="1"/>
          <p:nvPr/>
        </p:nvSpPr>
        <p:spPr>
          <a:xfrm>
            <a:off x="3225057" y="268788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F234306-4628-7124-8804-9E1DA5407A0C}"/>
              </a:ext>
            </a:extLst>
          </p:cNvPr>
          <p:cNvSpPr txBox="1"/>
          <p:nvPr/>
        </p:nvSpPr>
        <p:spPr>
          <a:xfrm>
            <a:off x="3225057" y="204301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3F60E8C-B099-C3D7-9F93-049863708944}"/>
              </a:ext>
            </a:extLst>
          </p:cNvPr>
          <p:cNvSpPr txBox="1"/>
          <p:nvPr/>
        </p:nvSpPr>
        <p:spPr>
          <a:xfrm>
            <a:off x="3225057" y="138071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01E6F87-8C2B-652D-3DDC-A142EC7BA6BA}"/>
              </a:ext>
            </a:extLst>
          </p:cNvPr>
          <p:cNvSpPr txBox="1"/>
          <p:nvPr/>
        </p:nvSpPr>
        <p:spPr>
          <a:xfrm>
            <a:off x="3225057" y="74044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6A3B3AF-3E2B-C806-E893-C75079882F95}"/>
              </a:ext>
            </a:extLst>
          </p:cNvPr>
          <p:cNvSpPr txBox="1"/>
          <p:nvPr/>
        </p:nvSpPr>
        <p:spPr>
          <a:xfrm>
            <a:off x="3210921" y="601994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322C0D3-AE57-F6E9-76E0-EE9DCEB28348}"/>
              </a:ext>
            </a:extLst>
          </p:cNvPr>
          <p:cNvSpPr txBox="1"/>
          <p:nvPr/>
        </p:nvSpPr>
        <p:spPr>
          <a:xfrm>
            <a:off x="3210921" y="550727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82F39AB-88D8-4401-48D4-1A5D7D86E781}"/>
              </a:ext>
            </a:extLst>
          </p:cNvPr>
          <p:cNvSpPr txBox="1"/>
          <p:nvPr/>
        </p:nvSpPr>
        <p:spPr>
          <a:xfrm>
            <a:off x="3210921" y="393057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F625E62-A8B6-61C6-1DBE-39B82BCD66E1}"/>
              </a:ext>
            </a:extLst>
          </p:cNvPr>
          <p:cNvSpPr txBox="1"/>
          <p:nvPr/>
        </p:nvSpPr>
        <p:spPr>
          <a:xfrm>
            <a:off x="3210921" y="496486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317A86A-D4CF-71CA-2D5A-CA6E0FB2B090}"/>
              </a:ext>
            </a:extLst>
          </p:cNvPr>
          <p:cNvSpPr txBox="1"/>
          <p:nvPr/>
        </p:nvSpPr>
        <p:spPr>
          <a:xfrm>
            <a:off x="3210921" y="443526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860C630-C9D7-A43D-0CAF-C945F11D9F2B}"/>
              </a:ext>
            </a:extLst>
          </p:cNvPr>
          <p:cNvSpPr txBox="1"/>
          <p:nvPr/>
        </p:nvSpPr>
        <p:spPr>
          <a:xfrm>
            <a:off x="5142014" y="3094039"/>
            <a:ext cx="3022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hromosome position (</a:t>
            </a:r>
            <a:r>
              <a:rPr lang="en-US" b="1" dirty="0" err="1"/>
              <a:t>cM</a:t>
            </a:r>
            <a:r>
              <a:rPr lang="en-US" b="1" dirty="0"/>
              <a:t>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1FC5EE4-3672-FE95-A27B-7956E633DED1}"/>
              </a:ext>
            </a:extLst>
          </p:cNvPr>
          <p:cNvSpPr txBox="1"/>
          <p:nvPr/>
        </p:nvSpPr>
        <p:spPr>
          <a:xfrm rot="16200000">
            <a:off x="2724696" y="1462517"/>
            <a:ext cx="631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O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1C6B346-7696-D105-5475-9946438AF0F4}"/>
              </a:ext>
            </a:extLst>
          </p:cNvPr>
          <p:cNvSpPr txBox="1"/>
          <p:nvPr/>
        </p:nvSpPr>
        <p:spPr>
          <a:xfrm rot="16200000">
            <a:off x="2724695" y="4685795"/>
            <a:ext cx="631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O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120590A-52F1-C2D8-7CB9-C715FF6EFCED}"/>
              </a:ext>
            </a:extLst>
          </p:cNvPr>
          <p:cNvSpPr txBox="1"/>
          <p:nvPr/>
        </p:nvSpPr>
        <p:spPr>
          <a:xfrm>
            <a:off x="3485179" y="407471"/>
            <a:ext cx="1789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hromosome 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D48BE1B-07FE-63E5-C0C4-093BAF512E5C}"/>
              </a:ext>
            </a:extLst>
          </p:cNvPr>
          <p:cNvSpPr txBox="1"/>
          <p:nvPr/>
        </p:nvSpPr>
        <p:spPr>
          <a:xfrm>
            <a:off x="3485179" y="3665752"/>
            <a:ext cx="17899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hromosome 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142FE00-6131-1463-19E4-CD5BEC16353A}"/>
              </a:ext>
            </a:extLst>
          </p:cNvPr>
          <p:cNvSpPr txBox="1"/>
          <p:nvPr/>
        </p:nvSpPr>
        <p:spPr>
          <a:xfrm>
            <a:off x="5140176" y="6408287"/>
            <a:ext cx="30226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hromosome position (</a:t>
            </a:r>
            <a:r>
              <a:rPr lang="en-US" b="1" dirty="0" err="1"/>
              <a:t>cM</a:t>
            </a:r>
            <a:r>
              <a:rPr lang="en-US" b="1" dirty="0"/>
              <a:t>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4C5A271-C7BE-0FCB-3420-F85F694B276F}"/>
              </a:ext>
            </a:extLst>
          </p:cNvPr>
          <p:cNvSpPr txBox="1"/>
          <p:nvPr/>
        </p:nvSpPr>
        <p:spPr>
          <a:xfrm>
            <a:off x="2521474" y="237152"/>
            <a:ext cx="40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7A6336D-FDA2-3569-72EF-4EFBC3429B39}"/>
              </a:ext>
            </a:extLst>
          </p:cNvPr>
          <p:cNvSpPr txBox="1"/>
          <p:nvPr/>
        </p:nvSpPr>
        <p:spPr>
          <a:xfrm>
            <a:off x="2521474" y="3282618"/>
            <a:ext cx="39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B0AA20AF-6329-3C92-6E2C-74FEB1E7B977}"/>
              </a:ext>
            </a:extLst>
          </p:cNvPr>
          <p:cNvCxnSpPr/>
          <p:nvPr/>
        </p:nvCxnSpPr>
        <p:spPr>
          <a:xfrm>
            <a:off x="3485179" y="4295313"/>
            <a:ext cx="6126480" cy="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3FB4F914-0A84-21C0-4C67-61674E280BFB}"/>
              </a:ext>
            </a:extLst>
          </p:cNvPr>
          <p:cNvSpPr txBox="1"/>
          <p:nvPr/>
        </p:nvSpPr>
        <p:spPr>
          <a:xfrm>
            <a:off x="8023052" y="394221"/>
            <a:ext cx="25391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2020 (Mean)</a:t>
            </a:r>
            <a:endParaRPr lang="en-US" sz="14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0F57206-D4E5-B773-D52B-8D33FDE42458}"/>
              </a:ext>
            </a:extLst>
          </p:cNvPr>
          <p:cNvSpPr txBox="1"/>
          <p:nvPr/>
        </p:nvSpPr>
        <p:spPr>
          <a:xfrm>
            <a:off x="7895593" y="3730965"/>
            <a:ext cx="253915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         2021 (Mean)</a:t>
            </a:r>
            <a:endParaRPr lang="en-US" sz="1400" b="1" dirty="0"/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5B07B668-974B-FD81-688E-AA8921260B9D}"/>
              </a:ext>
            </a:extLst>
          </p:cNvPr>
          <p:cNvCxnSpPr/>
          <p:nvPr/>
        </p:nvCxnSpPr>
        <p:spPr>
          <a:xfrm>
            <a:off x="3527409" y="1671461"/>
            <a:ext cx="6126480" cy="0"/>
          </a:xfrm>
          <a:prstGeom prst="line">
            <a:avLst/>
          </a:prstGeom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85467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9B639CE-1466-3AE3-43FB-9F739F316765}"/>
              </a:ext>
            </a:extLst>
          </p:cNvPr>
          <p:cNvSpPr txBox="1"/>
          <p:nvPr/>
        </p:nvSpPr>
        <p:spPr>
          <a:xfrm>
            <a:off x="404869" y="620344"/>
            <a:ext cx="11691649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. S2. </a:t>
            </a:r>
            <a:r>
              <a:rPr lang="en-US" dirty="0"/>
              <a:t>Logarithm of the odds (LOD) profiles for tar spot resistance on maize chromosome 1. Quantitative trait loci (QTL) were identified using the Intermated B73 × Mo17 (IBM) Syn5 recombinant inbred line (RIL) population. The horizontal, red, dashed line indicates the genome-wide significance threshold of LOD 3.8 (p &lt; 0.05), established via 1,000 permutations. The x axis represents the genetic distance in centimorgans (</a:t>
            </a:r>
            <a:r>
              <a:rPr lang="en-US" dirty="0" err="1"/>
              <a:t>cM</a:t>
            </a:r>
            <a:r>
              <a:rPr lang="en-US" dirty="0"/>
              <a:t>), and the y axis represents the LOD score. (</a:t>
            </a:r>
            <a:r>
              <a:rPr lang="en-US" b="1" dirty="0"/>
              <a:t>A</a:t>
            </a:r>
            <a:r>
              <a:rPr lang="en-US" dirty="0"/>
              <a:t>) LOD profile for tar spot response based on mean disease severity data from the 2020 growing season. </a:t>
            </a:r>
            <a:r>
              <a:rPr lang="en-US"/>
              <a:t>(</a:t>
            </a:r>
            <a:r>
              <a:rPr lang="en-US" b="1"/>
              <a:t>B</a:t>
            </a:r>
            <a:r>
              <a:rPr lang="en-US"/>
              <a:t>) LOD profile for tar spot response based on mean disease severity data from the 2021 growing season.</a:t>
            </a:r>
          </a:p>
        </p:txBody>
      </p:sp>
    </p:spTree>
    <p:extLst>
      <p:ext uri="{BB962C8B-B14F-4D97-AF65-F5344CB8AC3E}">
        <p14:creationId xmlns:p14="http://schemas.microsoft.com/office/powerpoint/2010/main" val="3416171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01</TotalTime>
  <Words>187</Words>
  <Application>Microsoft Macintosh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ksha Singh</dc:creator>
  <cp:lastModifiedBy>Stephen Goodwin</cp:lastModifiedBy>
  <cp:revision>3</cp:revision>
  <dcterms:created xsi:type="dcterms:W3CDTF">2026-01-26T11:29:21Z</dcterms:created>
  <dcterms:modified xsi:type="dcterms:W3CDTF">2026-05-01T21:11:53Z</dcterms:modified>
</cp:coreProperties>
</file>